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4" d="100"/>
          <a:sy n="114" d="100"/>
        </p:scale>
        <p:origin x="-246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27657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30470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69643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09749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03507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94434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60431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34663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17072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53752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73943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1B242-FF5D-4761-98B7-542701CF3F8C}" type="datetimeFigureOut">
              <a:rPr lang="en-US" smtClean="0"/>
              <a:pPr/>
              <a:t>4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F09D0B-C0C7-4422-A0DD-C09F775BFF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07256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62425"/>
            <a:ext cx="8229600" cy="604375"/>
          </a:xfrm>
        </p:spPr>
        <p:txBody>
          <a:bodyPr>
            <a:norm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rious tissues across different developmental stages for 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-</a:t>
            </a:r>
            <a:r>
              <a:rPr lang="en-US" sz="2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2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q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Content Placeholder 7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="" xmlns:p14="http://schemas.microsoft.com/office/powerpoint/2010/main" val="61803507"/>
              </p:ext>
            </p:extLst>
          </p:nvPr>
        </p:nvGraphicFramePr>
        <p:xfrm>
          <a:off x="64168" y="1090864"/>
          <a:ext cx="8991600" cy="5714998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124200"/>
                <a:gridCol w="3048000"/>
                <a:gridCol w="2819400"/>
              </a:tblGrid>
              <a:tr h="765943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mbryo stages </a:t>
                      </a:r>
                      <a:endParaRPr lang="en-US" sz="1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ate blastula, gastrula, </a:t>
                      </a:r>
                      <a:r>
                        <a:rPr lang="en-US" sz="1600" b="0" i="0" u="none" strike="noStrike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urula</a:t>
                      </a: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</a:t>
                      </a:r>
                    </a:p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ural-crest migration)</a:t>
                      </a:r>
                      <a:endParaRPr lang="en-US" sz="16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all parasite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proximal and distal intestine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reovulatory</a:t>
                      </a: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female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eye, tail skin)</a:t>
                      </a:r>
                    </a:p>
                  </a:txBody>
                  <a:tcPr marL="0" marR="0" marT="0" marB="0" anchor="b"/>
                </a:tc>
              </a:tr>
              <a:tr h="675741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arval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gill, kidney, liver, intestine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juvenile </a:t>
                      </a:r>
                      <a:endParaRPr lang="en-US" sz="1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testine, liver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vulatory female head skin</a:t>
                      </a:r>
                    </a:p>
                  </a:txBody>
                  <a:tcPr marL="0" marR="0" marT="0" marB="0" anchor="b"/>
                </a:tc>
              </a:tr>
              <a:tr h="670950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amorphosis 1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intestine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dult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intestine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respermiating</a:t>
                      </a: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male gill</a:t>
                      </a:r>
                    </a:p>
                  </a:txBody>
                  <a:tcPr marL="0" marR="0" marT="0" marB="0" anchor="b"/>
                </a:tc>
              </a:tr>
              <a:tr h="600394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amorphosis 2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liver, intestine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rain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0, 3, 21 dpi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permiating</a:t>
                      </a: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male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gill, muscle, head skin)</a:t>
                      </a:r>
                    </a:p>
                  </a:txBody>
                  <a:tcPr marL="0" marR="0" marT="0" marB="0" anchor="b"/>
                </a:tc>
              </a:tr>
              <a:tr h="60039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amorphosis 3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intestine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pinal cord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0,</a:t>
                      </a:r>
                      <a:r>
                        <a:rPr lang="en-US" sz="1600" b="0" i="0" u="none" strike="noStrike" kern="120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,</a:t>
                      </a:r>
                      <a:r>
                        <a:rPr lang="en-US" sz="1600" b="0" i="0" u="none" strike="noStrike" kern="120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 dpi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ture adult male rope tissue</a:t>
                      </a:r>
                    </a:p>
                  </a:txBody>
                  <a:tcPr marL="0" marR="0" marT="0" marB="0" anchor="b"/>
                </a:tc>
              </a:tr>
              <a:tr h="60039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amorphosis 4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intestine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ps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reshwater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gill, intestine, kidney)</a:t>
                      </a:r>
                    </a:p>
                  </a:txBody>
                  <a:tcPr marL="0" marR="0" marT="0" marB="0" anchor="b"/>
                </a:tc>
              </a:tr>
              <a:tr h="600394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amorphosis </a:t>
                      </a: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</a:p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liver, intestine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nocytes</a:t>
                      </a:r>
                      <a:endParaRPr lang="en-US" sz="16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alt water </a:t>
                      </a:r>
                      <a:endParaRPr lang="en-US" sz="1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ill, intestine)</a:t>
                      </a:r>
                    </a:p>
                  </a:txBody>
                  <a:tcPr marL="0" marR="0" marT="0" marB="0" anchor="b"/>
                </a:tc>
              </a:tr>
              <a:tr h="600394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amorphosis </a:t>
                      </a: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marL="0" algn="ctr" defTabSz="914400" rtl="0" eaLnBrk="1" fontAlgn="b" latinLnBrk="0" hangingPunct="1"/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intestine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utrophils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endPara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</a:tr>
              <a:tr h="60039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amorphosis 7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intestine, kidney)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kern="12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praneural</a:t>
                      </a:r>
                      <a:r>
                        <a:rPr lang="en-US" sz="1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tissue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endPara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</a:tr>
            </a:tbl>
          </a:graphicData>
        </a:graphic>
      </p:graphicFrame>
      <p:cxnSp>
        <p:nvCxnSpPr>
          <p:cNvPr id="9" name="Straight Connector 8"/>
          <p:cNvCxnSpPr/>
          <p:nvPr/>
        </p:nvCxnSpPr>
        <p:spPr>
          <a:xfrm>
            <a:off x="0" y="1002632"/>
            <a:ext cx="9144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="" xmlns:p14="http://schemas.microsoft.com/office/powerpoint/2010/main" val="22858677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83</Words>
  <Application>Microsoft Office PowerPoint</Application>
  <PresentationFormat>全屏显示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Various tissues across different developmental stages for mRNA-Seq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ssues for which we have mRNAseq</dc:title>
  <dc:creator>Ren Jianfeng</dc:creator>
  <cp:lastModifiedBy>lenovo</cp:lastModifiedBy>
  <cp:revision>12</cp:revision>
  <dcterms:created xsi:type="dcterms:W3CDTF">2014-03-13T18:02:19Z</dcterms:created>
  <dcterms:modified xsi:type="dcterms:W3CDTF">2015-04-06T12:45:57Z</dcterms:modified>
</cp:coreProperties>
</file>